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5F0DF67-4067-4B5D-8498-1603DB76ED9D}" v="49" dt="2023-02-24T21:41:16.21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C083E6E3-FA7D-4D7B-A595-EF9225AFEA82}" styleName="Style léger 1 - Accentuation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B4B98B0-60AC-42C2-AFA5-B58CD77FA1E5}" styleName="Helle Formatvorlage 1 - Akz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Helle Formatvorlage 1 - Akz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D27102A9-8310-4765-A935-A1911B00CA55}" styleName="Helle Formatvorlage 1 - Akz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717" autoAdjust="0"/>
  </p:normalViewPr>
  <p:slideViewPr>
    <p:cSldViewPr snapToGrid="0">
      <p:cViewPr varScale="1">
        <p:scale>
          <a:sx n="115" d="100"/>
          <a:sy n="115" d="100"/>
        </p:scale>
        <p:origin x="153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lam Saidou" userId="202de8f0797e068c" providerId="LiveId" clId="{15F0DF67-4067-4B5D-8498-1603DB76ED9D}"/>
    <pc:docChg chg="modSld">
      <pc:chgData name="Balam Saidou" userId="202de8f0797e068c" providerId="LiveId" clId="{15F0DF67-4067-4B5D-8498-1603DB76ED9D}" dt="2023-02-24T21:41:16.216" v="79"/>
      <pc:docMkLst>
        <pc:docMk/>
      </pc:docMkLst>
      <pc:sldChg chg="modSp mod">
        <pc:chgData name="Balam Saidou" userId="202de8f0797e068c" providerId="LiveId" clId="{15F0DF67-4067-4B5D-8498-1603DB76ED9D}" dt="2023-02-24T21:39:42.438" v="73"/>
        <pc:sldMkLst>
          <pc:docMk/>
          <pc:sldMk cId="2443873078" sldId="256"/>
        </pc:sldMkLst>
        <pc:graphicFrameChg chg="modGraphic">
          <ac:chgData name="Balam Saidou" userId="202de8f0797e068c" providerId="LiveId" clId="{15F0DF67-4067-4B5D-8498-1603DB76ED9D}" dt="2023-02-24T21:33:40.118" v="65" actId="20577"/>
          <ac:graphicFrameMkLst>
            <pc:docMk/>
            <pc:sldMk cId="2443873078" sldId="256"/>
            <ac:graphicFrameMk id="3" creationId="{EA52F746-2BC1-ADAA-7FB9-E861703740F7}"/>
          </ac:graphicFrameMkLst>
        </pc:graphicFrameChg>
        <pc:graphicFrameChg chg="mod">
          <ac:chgData name="Balam Saidou" userId="202de8f0797e068c" providerId="LiveId" clId="{15F0DF67-4067-4B5D-8498-1603DB76ED9D}" dt="2023-02-24T21:39:42.438" v="73"/>
          <ac:graphicFrameMkLst>
            <pc:docMk/>
            <pc:sldMk cId="2443873078" sldId="256"/>
            <ac:graphicFrameMk id="8" creationId="{42E20370-04F6-4DED-9ED7-AA55B95D01E6}"/>
          </ac:graphicFrameMkLst>
        </pc:graphicFrameChg>
        <pc:graphicFrameChg chg="mod">
          <ac:chgData name="Balam Saidou" userId="202de8f0797e068c" providerId="LiveId" clId="{15F0DF67-4067-4B5D-8498-1603DB76ED9D}" dt="2023-02-24T21:25:11.927" v="43"/>
          <ac:graphicFrameMkLst>
            <pc:docMk/>
            <pc:sldMk cId="2443873078" sldId="256"/>
            <ac:graphicFrameMk id="12" creationId="{E7553DE1-8C8C-46EF-88E1-541E418828F8}"/>
          </ac:graphicFrameMkLst>
        </pc:graphicFrameChg>
      </pc:sldChg>
      <pc:sldChg chg="modSp">
        <pc:chgData name="Balam Saidou" userId="202de8f0797e068c" providerId="LiveId" clId="{15F0DF67-4067-4B5D-8498-1603DB76ED9D}" dt="2023-02-24T21:41:16.216" v="79"/>
        <pc:sldMkLst>
          <pc:docMk/>
          <pc:sldMk cId="1249616141" sldId="257"/>
        </pc:sldMkLst>
        <pc:graphicFrameChg chg="mod">
          <ac:chgData name="Balam Saidou" userId="202de8f0797e068c" providerId="LiveId" clId="{15F0DF67-4067-4B5D-8498-1603DB76ED9D}" dt="2023-02-24T21:41:16.216" v="79"/>
          <ac:graphicFrameMkLst>
            <pc:docMk/>
            <pc:sldMk cId="1249616141" sldId="257"/>
            <ac:graphicFrameMk id="6" creationId="{0AA58107-8CEF-4E29-9975-629A5A022FC1}"/>
          </ac:graphicFrameMkLst>
        </pc:graphicFrameChg>
      </pc:sldChg>
      <pc:sldChg chg="modSp mod">
        <pc:chgData name="Balam Saidou" userId="202de8f0797e068c" providerId="LiveId" clId="{15F0DF67-4067-4B5D-8498-1603DB76ED9D}" dt="2023-02-24T21:40:15.577" v="76"/>
        <pc:sldMkLst>
          <pc:docMk/>
          <pc:sldMk cId="21157582" sldId="262"/>
        </pc:sldMkLst>
        <pc:graphicFrameChg chg="mod">
          <ac:chgData name="Balam Saidou" userId="202de8f0797e068c" providerId="LiveId" clId="{15F0DF67-4067-4B5D-8498-1603DB76ED9D}" dt="2023-02-24T21:40:15.577" v="76"/>
          <ac:graphicFrameMkLst>
            <pc:docMk/>
            <pc:sldMk cId="21157582" sldId="262"/>
            <ac:graphicFrameMk id="2" creationId="{8FCD13DD-A972-44B8-BE04-468ED915E699}"/>
          </ac:graphicFrameMkLst>
        </pc:graphicFrameChg>
        <pc:graphicFrameChg chg="modGraphic">
          <ac:chgData name="Balam Saidou" userId="202de8f0797e068c" providerId="LiveId" clId="{15F0DF67-4067-4B5D-8498-1603DB76ED9D}" dt="2023-02-24T21:33:09.612" v="50" actId="20577"/>
          <ac:graphicFrameMkLst>
            <pc:docMk/>
            <pc:sldMk cId="21157582" sldId="262"/>
            <ac:graphicFrameMk id="4" creationId="{41CD65C6-3CAA-1D47-BD30-8C00DB59D556}"/>
          </ac:graphicFrameMkLst>
        </pc:graphicFrameChg>
        <pc:graphicFrameChg chg="mod">
          <ac:chgData name="Balam Saidou" userId="202de8f0797e068c" providerId="LiveId" clId="{15F0DF67-4067-4B5D-8498-1603DB76ED9D}" dt="2023-02-24T21:18:18.493" v="39"/>
          <ac:graphicFrameMkLst>
            <pc:docMk/>
            <pc:sldMk cId="21157582" sldId="262"/>
            <ac:graphicFrameMk id="6" creationId="{D8EC7DBC-17AC-4193-B1AB-8752813493AA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034A75-5C4F-4D45-A26E-2F4AFEE9F9EC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77CFF0-8A95-40C7-B24B-61A8147E036A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6746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2557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0535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5481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1851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9550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791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7313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0054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4621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8397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9668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EBE03-9305-4239-A24F-95E5FD8875D3}" type="datetimeFigureOut">
              <a:rPr lang="fr-FR" smtClean="0"/>
              <a:t>17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C84D0-E350-409B-B799-A40EDF20739E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1100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52E1312-69BC-42EF-BF77-8AABBF5929A9}"/>
              </a:ext>
            </a:extLst>
          </p:cNvPr>
          <p:cNvSpPr txBox="1"/>
          <p:nvPr/>
        </p:nvSpPr>
        <p:spPr>
          <a:xfrm>
            <a:off x="559312" y="479296"/>
            <a:ext cx="6952328" cy="58169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13   QMAKGEVKYVPPEELNKDVSGFFGFK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FSSKGVHNLEPILTEKRSLV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IYSYFIYDKI 7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++**G***+**P**LN*++SGF*G+KCNFS++GVHNL+P*+*E+RS+*C+I+SYFIYDKI</a:t>
            </a:r>
            <a:endParaRPr kumimoji="0" lang="fr-FR" sz="1200" b="0" i="1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23   RIISGNNDFCKPSSLNSEISGFIGYK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FSNEGVHNLKPDMRERRSIF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IHSYFIYDKI 8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73   KLTIPKKIPGSKFKMLPEK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QTVYTNYEKRTEEKIENMGLVEYEVKEDDSNSEYTEKIL 13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+L*IPKK****+FK+LPEKCFQ*VYT+YE*R*E**I**+GL+EYE++E+D+N**Y*E+*+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83   RLIIPKKSSSPEFKILPEK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QKVYTDYENRVETDISELGLIEYEIEENDTNPNYNERTI 14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133  TISPFNTKDVEFFC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NSENVISNVKGRVALVQVNVLKYPHKITSINLTKEPYSYLPNQ 19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ISPF+*KD+EFFC*CDN+E*VIS+++GR*A+V*V*VLKYPH*I***NLT*+*++YLP**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143  TISPFSPKDIEFFCF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NTEKVISSIEGRSAMVHVRVLKYPHNILFTNLTNDLFTYLPKT 20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193  VDKTSFKSNKLDLELQDGELVVLA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KVDDKCFKKGKDTSPLSLYKSNKIVYHKNLSIFK 25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++++F*SN*L++EL*DGEL*VLACE*++*KCF++GK+****+LYKSNKI+YH+*L+IFK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203  YNESNFVSNVLEVELNDGELFVLA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LINKKCFQEGKEK---ALYKSNKIIYHEKLTIFK 259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253  APVYVKSADVTAECS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VDSTIYTLSLKPVYTKKLIHG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FSSDKST-HNFTNHVDMAEL 311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P*YV*S*DV**EC+C***+**Y*+*LKP*Y*KK+IHGCNFSS+*S+*H*FT+*+D++*+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260  APFYVTSKDVNTECT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FKNNNYKIVLKPKYEKKVIHG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FSSNVSSKHTFTDSLDISLV 319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312  GENAQIT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IELVDTSYNHLIGMS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GEVLPE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FQVYQRESPELEPSKIVYLDTQLNIG  371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++A*I+C++*L*+**YNHL+G++CPG+++P+CFFQVYQ*ES*ELEPS*IVYLD+Q+NIG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320  DDSAHIS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VHLSEPKYNHLVGLN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GDIIPD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FQVYQPESEELEPSNIVYLDSQINIG 379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372  NVEYFEDSKGENIVKIFGLVGSIPKTTSFT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CRKGRKIGYMSVKIAAGYFGFLAKIFIL 431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++EY+ED++G++*+K+FG+VGSIPKTTSFTCIC+K*+K**YM+V*I*+*Y+GFLAK*FI*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380  DIEYYEDAEGDDKIKLFGIVGSIPKTTSFT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CKKDKKSAYMTVTIDSAYYGFLAKTFIF 439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431  LIV 434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LIV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440  LIV 442</a:t>
            </a:r>
            <a:endParaRPr kumimoji="0" lang="fr-F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56C7518-CF45-471B-B479-9FBD0CC12CA7}"/>
              </a:ext>
            </a:extLst>
          </p:cNvPr>
          <p:cNvSpPr txBox="1"/>
          <p:nvPr/>
        </p:nvSpPr>
        <p:spPr>
          <a:xfrm>
            <a:off x="319050" y="64159"/>
            <a:ext cx="27317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Calibri" panose="020F0502020204030204" pitchFamily="34" charset="0"/>
                <a:cs typeface="Arial" panose="020B0604020202020204" pitchFamily="34" charset="0"/>
              </a:rPr>
              <a:t>Supplemental</a:t>
            </a:r>
            <a:r>
              <a:rPr kumimoji="0" lang="en-US" sz="1800" b="1" i="0" u="none" strike="noStrike" kern="1200" cap="none" spc="0" normalizeH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Calibri" panose="020F0502020204030204" pitchFamily="34" charset="0"/>
                <a:cs typeface="Arial" panose="020B0604020202020204" pitchFamily="34" charset="0"/>
              </a:rPr>
              <a:t> figure</a:t>
            </a:r>
            <a:r>
              <a:rPr kumimoji="0" lang="en-US" sz="18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559311" y="6280523"/>
            <a:ext cx="17222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v</a:t>
            </a:r>
            <a:r>
              <a:rPr kumimoji="0" lang="de-DE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sym typeface="Wingdings" panose="05000000000000000000" pitchFamily="2" charset="2"/>
              </a:rPr>
              <a:t>Pvs48/45 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sym typeface="Wingdings" panose="05000000000000000000" pitchFamily="2" charset="2"/>
              </a:rPr>
              <a:t>sequenc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f</a:t>
            </a:r>
            <a:r>
              <a:rPr kumimoji="0" lang="de-DE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sym typeface="Wingdings" panose="05000000000000000000" pitchFamily="2" charset="2"/>
              </a:rPr>
              <a:t>Pfs48/45 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sym typeface="Wingdings" panose="05000000000000000000" pitchFamily="2" charset="2"/>
              </a:rPr>
              <a:t>sequence</a:t>
            </a:r>
            <a:endParaRPr kumimoji="0" lang="fr-CH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9560203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Bildschirmpräsentation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Wingdings</vt:lpstr>
      <vt:lpstr>Thème 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lam Saidou</dc:creator>
  <cp:lastModifiedBy>BALAM</cp:lastModifiedBy>
  <cp:revision>246</cp:revision>
  <dcterms:created xsi:type="dcterms:W3CDTF">2019-09-08T16:28:22Z</dcterms:created>
  <dcterms:modified xsi:type="dcterms:W3CDTF">2023-04-17T12:59:30Z</dcterms:modified>
</cp:coreProperties>
</file>